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81717"/>
    <a:srgbClr val="AFAB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7" autoAdjust="0"/>
    <p:restoredTop sz="94660"/>
  </p:normalViewPr>
  <p:slideViewPr>
    <p:cSldViewPr snapToGrid="0">
      <p:cViewPr varScale="1">
        <p:scale>
          <a:sx n="142" d="100"/>
          <a:sy n="142" d="100"/>
        </p:scale>
        <p:origin x="96" y="2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9403E2-192D-4889-A1C0-4383D9AEFC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C5847CE-5E2E-42E0-9C83-3D90037C5F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2657E7-E9E7-4DCC-B6D3-CF2D68A6B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FC21FE5-5856-4603-BE2B-160FF080D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D5F09C-FC9D-4688-A464-2C9424B3D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3230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FB13FA-3C50-4772-A10C-AAE8EDD1B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5B3D70D-B92D-49CB-8EB8-4305E9E44B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573F40-77B3-4899-9714-EAE1CAD9C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10456A6-91F0-492C-BE49-557778713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F485209-CF0A-4866-BD04-A988E8789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3315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2456F5E-2EE6-4A53-A9FF-3C3CBCB40B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24D8AB3-3271-43BC-A9A2-D72BAE9112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CE07BF1-0446-43DC-8370-C9486B1B8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363095B-7B76-48FD-AB54-52220776F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B2FA7C5-A241-4507-98DE-1887391EA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9499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D2F8AC-1C08-4495-908D-2921900E2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A9328E0-E30F-476B-92BA-33618E340C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14BD10E-AD57-4597-995F-6192D865E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A6E2521-EF0A-4254-9872-E1412D77F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BD68B47-D09F-4DE9-BE60-3A5715923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8354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DC5E0F-CF14-41E7-B47D-7B558F915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52DF913-ACCB-4206-96C7-223B9602E2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5B3106D-53A2-431D-8A92-3CB8F1216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3C5AC0-7944-465F-9AA2-E21C4C420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D4AC70-FBD7-49B6-A547-C161D45DA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3275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73B2CD-DFC4-4F7F-BC7B-ED2E186AA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20943CF-31B6-41BE-975C-F4FF88892A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E732910-380D-47A8-BEE6-E03C18489E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0BD8F6B-6BE0-458F-ACF7-BA6715909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9BA166-FA8D-42E2-8986-EA72B8687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25A6C0D-44BB-434E-8529-4F50663B2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332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1519AA-78DE-4C58-9426-77F26284B4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F440BC2-44E8-4FC9-A56C-7AAF410CBE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830B316-B3A0-4ED0-82CC-9B439622C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6C24683-C5DF-42CC-A3F7-2E6F3D64EE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D176DF0-E59E-4632-BC15-6059C76160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5A5BE3C-0F94-4558-9500-66906BECF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F0F5626-B0CD-4508-9C03-7FDF25DBD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AE3B2B9-C690-4A69-B292-0BC9866FD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71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A41ABD-4AAA-4E1D-9420-A2A7C22E7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6ED2F707-3576-4B8C-B533-E903992DE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09BECF6-4B31-47EC-AC0F-45B6A50C5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821E30F-F158-483F-982B-163DF9B0C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0050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D915B81-727E-4B97-B64D-D2E0F0669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2940CEE-E522-4A1F-A988-54C31BBE5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926942C-0102-4B19-BADA-3930F4634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3342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0D7A92-49C7-4A15-B008-8838B0103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FA3AC68-3DCC-4207-A6E8-588BC6A31E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C85B975-216F-42F6-86FB-A688D6565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6B95D2B-A055-4B9D-A66E-6BAB15C99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8EA7389-122D-449B-8AC3-C83490E63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20E0C0E-4122-462F-9923-4A12DD775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777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D5A32C5-77A9-46DD-94FF-69EADAD16F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0FA47C6-7E1B-48CD-9396-C963188311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8CE603E-FDFE-46FD-8AC0-82E8159E3B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E2962D1-9958-4D6A-97EA-4215BF32F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BD55F66-4031-4E40-A58C-0562F9F20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EEF5483-7970-48E6-A9B7-A9675E706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0639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969EF302-CFB3-4E34-B527-3BDD1564A5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ABCABF8-D706-4DCF-80BC-437A8706FA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110E5E4-3231-44D6-907D-AEC83E57EA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FD4F6-A724-4748-9480-1B2BE25585C4}" type="datetimeFigureOut">
              <a:rPr lang="de-DE" smtClean="0"/>
              <a:t>13.05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B185390-E4B4-477B-ADA7-4AFB559953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99DAFAF-5281-4582-A36E-8AD7DD5C33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FBE0B-0FD8-4614-930D-EA0B6AC3BB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8376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ieren 22">
            <a:extLst>
              <a:ext uri="{FF2B5EF4-FFF2-40B4-BE49-F238E27FC236}">
                <a16:creationId xmlns:a16="http://schemas.microsoft.com/office/drawing/2014/main" id="{CE749919-B8FA-4D5D-8075-13975B624219}"/>
              </a:ext>
            </a:extLst>
          </p:cNvPr>
          <p:cNvGrpSpPr/>
          <p:nvPr/>
        </p:nvGrpSpPr>
        <p:grpSpPr>
          <a:xfrm>
            <a:off x="3023822" y="449136"/>
            <a:ext cx="5849933" cy="4960338"/>
            <a:chOff x="716051" y="1087765"/>
            <a:chExt cx="5849933" cy="4960338"/>
          </a:xfrm>
        </p:grpSpPr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FC894B1A-D267-4B84-B9D9-E795EB4598F1}"/>
                </a:ext>
              </a:extLst>
            </p:cNvPr>
            <p:cNvGrpSpPr/>
            <p:nvPr/>
          </p:nvGrpSpPr>
          <p:grpSpPr>
            <a:xfrm>
              <a:off x="716051" y="1087765"/>
              <a:ext cx="5849933" cy="4960338"/>
              <a:chOff x="716051" y="1087765"/>
              <a:chExt cx="5849933" cy="4960338"/>
            </a:xfrm>
          </p:grpSpPr>
          <p:pic>
            <p:nvPicPr>
              <p:cNvPr id="16" name="Grafik 15">
                <a:extLst>
                  <a:ext uri="{FF2B5EF4-FFF2-40B4-BE49-F238E27FC236}">
                    <a16:creationId xmlns:a16="http://schemas.microsoft.com/office/drawing/2014/main" id="{76FFE16A-B7D7-4DDF-BEE9-C9956549AD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6051" y="1087765"/>
                <a:ext cx="3725315" cy="4960338"/>
              </a:xfrm>
              <a:prstGeom prst="rect">
                <a:avLst/>
              </a:prstGeom>
            </p:spPr>
          </p:pic>
          <p:sp>
            <p:nvSpPr>
              <p:cNvPr id="4" name="Rechteck 3">
                <a:extLst>
                  <a:ext uri="{FF2B5EF4-FFF2-40B4-BE49-F238E27FC236}">
                    <a16:creationId xmlns:a16="http://schemas.microsoft.com/office/drawing/2014/main" id="{BC83DA5A-B959-4AF1-9C86-9DF0B0ED58B8}"/>
                  </a:ext>
                </a:extLst>
              </p:cNvPr>
              <p:cNvSpPr/>
              <p:nvPr/>
            </p:nvSpPr>
            <p:spPr>
              <a:xfrm>
                <a:off x="3338106" y="1310179"/>
                <a:ext cx="1547403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Apuli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6" name="Rechteck 5">
                <a:extLst>
                  <a:ext uri="{FF2B5EF4-FFF2-40B4-BE49-F238E27FC236}">
                    <a16:creationId xmlns:a16="http://schemas.microsoft.com/office/drawing/2014/main" id="{CA02E966-8A4E-46C9-969F-08122BF922A4}"/>
                  </a:ext>
                </a:extLst>
              </p:cNvPr>
              <p:cNvSpPr/>
              <p:nvPr/>
            </p:nvSpPr>
            <p:spPr>
              <a:xfrm>
                <a:off x="3347902" y="1675212"/>
                <a:ext cx="1547401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Greece</a:t>
                </a:r>
                <a:endParaRPr lang="de-DE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" name="Rechteck 6">
                <a:extLst>
                  <a:ext uri="{FF2B5EF4-FFF2-40B4-BE49-F238E27FC236}">
                    <a16:creationId xmlns:a16="http://schemas.microsoft.com/office/drawing/2014/main" id="{78FD3810-0D00-4253-82D6-806B302E7099}"/>
                  </a:ext>
                </a:extLst>
              </p:cNvPr>
              <p:cNvSpPr/>
              <p:nvPr/>
            </p:nvSpPr>
            <p:spPr>
              <a:xfrm>
                <a:off x="3644718" y="2013758"/>
                <a:ext cx="1224765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Apuli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8" name="Rechteck 7">
                <a:extLst>
                  <a:ext uri="{FF2B5EF4-FFF2-40B4-BE49-F238E27FC236}">
                    <a16:creationId xmlns:a16="http://schemas.microsoft.com/office/drawing/2014/main" id="{23C7BCCF-D8C5-4655-8077-59624D6DCEF7}"/>
                  </a:ext>
                </a:extLst>
              </p:cNvPr>
              <p:cNvSpPr/>
              <p:nvPr/>
            </p:nvSpPr>
            <p:spPr>
              <a:xfrm>
                <a:off x="4453888" y="2400201"/>
                <a:ext cx="1224765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Greece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Farsal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9" name="Rechteck 8">
                <a:extLst>
                  <a:ext uri="{FF2B5EF4-FFF2-40B4-BE49-F238E27FC236}">
                    <a16:creationId xmlns:a16="http://schemas.microsoft.com/office/drawing/2014/main" id="{A5A33A8B-7249-4CB2-9792-96E3D6437E22}"/>
                  </a:ext>
                </a:extLst>
              </p:cNvPr>
              <p:cNvSpPr/>
              <p:nvPr/>
            </p:nvSpPr>
            <p:spPr>
              <a:xfrm>
                <a:off x="4055769" y="2753194"/>
                <a:ext cx="1224765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Greece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Farsal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10" name="Rechteck 9">
                <a:extLst>
                  <a:ext uri="{FF2B5EF4-FFF2-40B4-BE49-F238E27FC236}">
                    <a16:creationId xmlns:a16="http://schemas.microsoft.com/office/drawing/2014/main" id="{CB85489B-9A92-4285-841D-0F91872BD1F5}"/>
                  </a:ext>
                </a:extLst>
              </p:cNvPr>
              <p:cNvSpPr/>
              <p:nvPr/>
            </p:nvSpPr>
            <p:spPr>
              <a:xfrm>
                <a:off x="2361653" y="3123738"/>
                <a:ext cx="1224765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Sicily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11" name="Rechteck 10">
                <a:extLst>
                  <a:ext uri="{FF2B5EF4-FFF2-40B4-BE49-F238E27FC236}">
                    <a16:creationId xmlns:a16="http://schemas.microsoft.com/office/drawing/2014/main" id="{0D568AF0-5558-4FB0-AAA6-21D58FDD9E89}"/>
                  </a:ext>
                </a:extLst>
              </p:cNvPr>
              <p:cNvSpPr/>
              <p:nvPr/>
            </p:nvSpPr>
            <p:spPr>
              <a:xfrm>
                <a:off x="2829375" y="3480426"/>
                <a:ext cx="2568572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Sicily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12" name="Rechteck 11">
                <a:extLst>
                  <a:ext uri="{FF2B5EF4-FFF2-40B4-BE49-F238E27FC236}">
                    <a16:creationId xmlns:a16="http://schemas.microsoft.com/office/drawing/2014/main" id="{1F79ED22-E179-4C62-95AA-B9F15496F6DC}"/>
                  </a:ext>
                </a:extLst>
              </p:cNvPr>
              <p:cNvSpPr/>
              <p:nvPr/>
            </p:nvSpPr>
            <p:spPr>
              <a:xfrm>
                <a:off x="2874912" y="4211418"/>
                <a:ext cx="2568572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Sardini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13" name="Rechteck 12">
                <a:extLst>
                  <a:ext uri="{FF2B5EF4-FFF2-40B4-BE49-F238E27FC236}">
                    <a16:creationId xmlns:a16="http://schemas.microsoft.com/office/drawing/2014/main" id="{D3A20A10-61F5-4198-A4C8-7E332CF50841}"/>
                  </a:ext>
                </a:extLst>
              </p:cNvPr>
              <p:cNvSpPr/>
              <p:nvPr/>
            </p:nvSpPr>
            <p:spPr>
              <a:xfrm>
                <a:off x="3628748" y="3858522"/>
                <a:ext cx="2568572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 err="1">
                    <a:solidFill>
                      <a:schemeClr val="tx1"/>
                    </a:solidFill>
                  </a:rPr>
                  <a:t>Italy</a:t>
                </a:r>
                <a:r>
                  <a:rPr lang="de-DE" sz="1100" dirty="0">
                    <a:solidFill>
                      <a:schemeClr val="tx1"/>
                    </a:solidFill>
                  </a:rPr>
                  <a:t> (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Sardinia</a:t>
                </a:r>
                <a:r>
                  <a:rPr lang="de-DE" sz="1100" dirty="0">
                    <a:solidFill>
                      <a:schemeClr val="tx1"/>
                    </a:solidFill>
                  </a:rPr>
                  <a:t>)</a:t>
                </a:r>
              </a:p>
            </p:txBody>
          </p:sp>
          <p:sp>
            <p:nvSpPr>
              <p:cNvPr id="14" name="Rechteck 13">
                <a:extLst>
                  <a:ext uri="{FF2B5EF4-FFF2-40B4-BE49-F238E27FC236}">
                    <a16:creationId xmlns:a16="http://schemas.microsoft.com/office/drawing/2014/main" id="{AC1FE091-FE79-4EF6-BCE8-EC54D1751810}"/>
                  </a:ext>
                </a:extLst>
              </p:cNvPr>
              <p:cNvSpPr/>
              <p:nvPr/>
            </p:nvSpPr>
            <p:spPr>
              <a:xfrm>
                <a:off x="3997412" y="4576616"/>
                <a:ext cx="2568572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>
                    <a:solidFill>
                      <a:schemeClr val="tx1"/>
                    </a:solidFill>
                  </a:rPr>
                  <a:t>France</a:t>
                </a:r>
              </a:p>
            </p:txBody>
          </p:sp>
          <p:sp>
            <p:nvSpPr>
              <p:cNvPr id="15" name="Rechteck 14">
                <a:extLst>
                  <a:ext uri="{FF2B5EF4-FFF2-40B4-BE49-F238E27FC236}">
                    <a16:creationId xmlns:a16="http://schemas.microsoft.com/office/drawing/2014/main" id="{154DCAF8-96C2-408E-AD91-ABB4B270982A}"/>
                  </a:ext>
                </a:extLst>
              </p:cNvPr>
              <p:cNvSpPr/>
              <p:nvPr/>
            </p:nvSpPr>
            <p:spPr>
              <a:xfrm>
                <a:off x="3993972" y="4947276"/>
                <a:ext cx="2568572" cy="1528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de-DE" sz="1100" dirty="0">
                    <a:solidFill>
                      <a:schemeClr val="tx1"/>
                    </a:solidFill>
                  </a:rPr>
                  <a:t>France</a:t>
                </a:r>
              </a:p>
            </p:txBody>
          </p:sp>
        </p:grpSp>
        <p:sp>
          <p:nvSpPr>
            <p:cNvPr id="3" name="Pfeil: nach rechts 2">
              <a:extLst>
                <a:ext uri="{FF2B5EF4-FFF2-40B4-BE49-F238E27FC236}">
                  <a16:creationId xmlns:a16="http://schemas.microsoft.com/office/drawing/2014/main" id="{B5AAA183-0E4E-4266-93FA-B9B5206391A7}"/>
                </a:ext>
              </a:extLst>
            </p:cNvPr>
            <p:cNvSpPr/>
            <p:nvPr/>
          </p:nvSpPr>
          <p:spPr>
            <a:xfrm rot="10800000">
              <a:off x="3984172" y="1694807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17" name="Pfeil: nach rechts 16">
              <a:extLst>
                <a:ext uri="{FF2B5EF4-FFF2-40B4-BE49-F238E27FC236}">
                  <a16:creationId xmlns:a16="http://schemas.microsoft.com/office/drawing/2014/main" id="{13674B12-41E6-42C2-B4BD-3AE9AF15315A}"/>
                </a:ext>
              </a:extLst>
            </p:cNvPr>
            <p:cNvSpPr/>
            <p:nvPr/>
          </p:nvSpPr>
          <p:spPr>
            <a:xfrm rot="10800000">
              <a:off x="5649686" y="2427778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18" name="Pfeil: nach rechts 17">
              <a:extLst>
                <a:ext uri="{FF2B5EF4-FFF2-40B4-BE49-F238E27FC236}">
                  <a16:creationId xmlns:a16="http://schemas.microsoft.com/office/drawing/2014/main" id="{FC3EA1A3-17E6-4D5F-B0FD-E7624EDCF0C0}"/>
                </a:ext>
              </a:extLst>
            </p:cNvPr>
            <p:cNvSpPr/>
            <p:nvPr/>
          </p:nvSpPr>
          <p:spPr>
            <a:xfrm rot="10800000">
              <a:off x="5301343" y="2790635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19" name="Pfeil: nach rechts 18">
              <a:extLst>
                <a:ext uri="{FF2B5EF4-FFF2-40B4-BE49-F238E27FC236}">
                  <a16:creationId xmlns:a16="http://schemas.microsoft.com/office/drawing/2014/main" id="{7137DFDF-2610-48DA-B9BB-EE7623C97AA5}"/>
                </a:ext>
              </a:extLst>
            </p:cNvPr>
            <p:cNvSpPr/>
            <p:nvPr/>
          </p:nvSpPr>
          <p:spPr>
            <a:xfrm rot="10800000">
              <a:off x="3802742" y="3501108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20" name="Pfeil: nach rechts 19">
              <a:extLst>
                <a:ext uri="{FF2B5EF4-FFF2-40B4-BE49-F238E27FC236}">
                  <a16:creationId xmlns:a16="http://schemas.microsoft.com/office/drawing/2014/main" id="{64867DE9-C150-4CF3-BA7C-1FD713CD8157}"/>
                </a:ext>
              </a:extLst>
            </p:cNvPr>
            <p:cNvSpPr/>
            <p:nvPr/>
          </p:nvSpPr>
          <p:spPr>
            <a:xfrm rot="10800000">
              <a:off x="4669920" y="3879204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21" name="Pfeil: nach rechts 20">
              <a:extLst>
                <a:ext uri="{FF2B5EF4-FFF2-40B4-BE49-F238E27FC236}">
                  <a16:creationId xmlns:a16="http://schemas.microsoft.com/office/drawing/2014/main" id="{C252754A-CE4A-4DB6-BDE3-E7A0632CD8CA}"/>
                </a:ext>
              </a:extLst>
            </p:cNvPr>
            <p:cNvSpPr/>
            <p:nvPr/>
          </p:nvSpPr>
          <p:spPr>
            <a:xfrm rot="10800000">
              <a:off x="4626369" y="4967958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CAAE00EF-EE2C-472E-97DD-1972AE9B334C}"/>
                </a:ext>
              </a:extLst>
            </p:cNvPr>
            <p:cNvSpPr txBox="1"/>
            <p:nvPr/>
          </p:nvSpPr>
          <p:spPr>
            <a:xfrm>
              <a:off x="3453957" y="2713920"/>
              <a:ext cx="6222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isolate</a:t>
              </a:r>
              <a:r>
                <a:rPr lang="de-DE" sz="1000" dirty="0"/>
                <a:t> 1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F40C4508-96AB-495C-98D5-2D06F687D8B8}"/>
                </a:ext>
              </a:extLst>
            </p:cNvPr>
            <p:cNvSpPr txBox="1"/>
            <p:nvPr/>
          </p:nvSpPr>
          <p:spPr>
            <a:xfrm>
              <a:off x="3893457" y="2351314"/>
              <a:ext cx="6222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isolate</a:t>
              </a:r>
              <a:r>
                <a:rPr lang="de-DE" sz="1000" dirty="0"/>
                <a:t> 2</a:t>
              </a:r>
            </a:p>
          </p:txBody>
        </p:sp>
        <p:sp>
          <p:nvSpPr>
            <p:cNvPr id="24" name="Pfeil: nach rechts 23">
              <a:extLst>
                <a:ext uri="{FF2B5EF4-FFF2-40B4-BE49-F238E27FC236}">
                  <a16:creationId xmlns:a16="http://schemas.microsoft.com/office/drawing/2014/main" id="{4D589057-23A7-4228-A583-60DB163AC2C5}"/>
                </a:ext>
              </a:extLst>
            </p:cNvPr>
            <p:cNvSpPr/>
            <p:nvPr/>
          </p:nvSpPr>
          <p:spPr>
            <a:xfrm rot="10800000">
              <a:off x="4270829" y="1328322"/>
              <a:ext cx="243114" cy="1114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</p:grpSp>
      <p:sp>
        <p:nvSpPr>
          <p:cNvPr id="25" name="Textfeld 24">
            <a:extLst>
              <a:ext uri="{FF2B5EF4-FFF2-40B4-BE49-F238E27FC236}">
                <a16:creationId xmlns:a16="http://schemas.microsoft.com/office/drawing/2014/main" id="{E24A6570-F05A-488C-9192-D3683C382A71}"/>
              </a:ext>
            </a:extLst>
          </p:cNvPr>
          <p:cNvSpPr txBox="1"/>
          <p:nvPr/>
        </p:nvSpPr>
        <p:spPr>
          <a:xfrm>
            <a:off x="580572" y="5514605"/>
            <a:ext cx="1091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</a:t>
            </a:r>
            <a:r>
              <a:rPr lang="en-US" b="1"/>
              <a:t>S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39881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reitbild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aolo Margaria</dc:creator>
  <cp:lastModifiedBy>Paolo Margaria</cp:lastModifiedBy>
  <cp:revision>42</cp:revision>
  <dcterms:created xsi:type="dcterms:W3CDTF">2022-04-06T13:36:12Z</dcterms:created>
  <dcterms:modified xsi:type="dcterms:W3CDTF">2022-05-13T11:45:32Z</dcterms:modified>
</cp:coreProperties>
</file>